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74"/>
  </p:normalViewPr>
  <p:slideViewPr>
    <p:cSldViewPr snapToGrid="0">
      <p:cViewPr varScale="1">
        <p:scale>
          <a:sx n="124" d="100"/>
          <a:sy n="124" d="100"/>
        </p:scale>
        <p:origin x="64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hakal, Kshitiz" userId="6ff78c19-3d13-44c6-91c3-34d44c8b7c49" providerId="ADAL" clId="{EEC36DBD-1200-4536-B297-1FC5B87D62A0}"/>
    <pc:docChg chg="custSel addSld delSld modSld">
      <pc:chgData name="Dhakal, Kshitiz" userId="6ff78c19-3d13-44c6-91c3-34d44c8b7c49" providerId="ADAL" clId="{EEC36DBD-1200-4536-B297-1FC5B87D62A0}" dt="2022-12-27T21:21:34.163" v="7" actId="1076"/>
      <pc:docMkLst>
        <pc:docMk/>
      </pc:docMkLst>
      <pc:sldChg chg="add del">
        <pc:chgData name="Dhakal, Kshitiz" userId="6ff78c19-3d13-44c6-91c3-34d44c8b7c49" providerId="ADAL" clId="{EEC36DBD-1200-4536-B297-1FC5B87D62A0}" dt="2022-12-27T21:21:22.337" v="2" actId="2696"/>
        <pc:sldMkLst>
          <pc:docMk/>
          <pc:sldMk cId="2693386394" sldId="256"/>
        </pc:sldMkLst>
      </pc:sldChg>
      <pc:sldChg chg="addSp delSp modSp add">
        <pc:chgData name="Dhakal, Kshitiz" userId="6ff78c19-3d13-44c6-91c3-34d44c8b7c49" providerId="ADAL" clId="{EEC36DBD-1200-4536-B297-1FC5B87D62A0}" dt="2022-12-27T21:21:34.163" v="7" actId="1076"/>
        <pc:sldMkLst>
          <pc:docMk/>
          <pc:sldMk cId="2355828696" sldId="257"/>
        </pc:sldMkLst>
        <pc:spChg chg="del">
          <ac:chgData name="Dhakal, Kshitiz" userId="6ff78c19-3d13-44c6-91c3-34d44c8b7c49" providerId="ADAL" clId="{EEC36DBD-1200-4536-B297-1FC5B87D62A0}" dt="2022-12-27T21:21:24.038" v="3" actId="478"/>
          <ac:spMkLst>
            <pc:docMk/>
            <pc:sldMk cId="2355828696" sldId="257"/>
            <ac:spMk id="2" creationId="{C44B4B73-1FB5-4A7A-BA88-772889707E75}"/>
          </ac:spMkLst>
        </pc:spChg>
        <pc:spChg chg="del">
          <ac:chgData name="Dhakal, Kshitiz" userId="6ff78c19-3d13-44c6-91c3-34d44c8b7c49" providerId="ADAL" clId="{EEC36DBD-1200-4536-B297-1FC5B87D62A0}" dt="2022-12-27T21:21:25.659" v="4" actId="478"/>
          <ac:spMkLst>
            <pc:docMk/>
            <pc:sldMk cId="2355828696" sldId="257"/>
            <ac:spMk id="3" creationId="{94E61961-D26C-4EF5-AC8F-BB7015EEA2B5}"/>
          </ac:spMkLst>
        </pc:spChg>
        <pc:picChg chg="add mod">
          <ac:chgData name="Dhakal, Kshitiz" userId="6ff78c19-3d13-44c6-91c3-34d44c8b7c49" providerId="ADAL" clId="{EEC36DBD-1200-4536-B297-1FC5B87D62A0}" dt="2022-12-27T21:21:34.163" v="7" actId="1076"/>
          <ac:picMkLst>
            <pc:docMk/>
            <pc:sldMk cId="2355828696" sldId="257"/>
            <ac:picMk id="5" creationId="{7A634CC0-05AD-40C0-96A7-A7B5FEBA4417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E8F4BA-FF76-466C-8639-0417051D379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CA57C18-65B2-4EA6-9B74-1C42A217CBA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00E5D6-A04D-4313-A909-A564843001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38FF8-C19A-4E7F-824C-58AC62B8B22C}" type="datetimeFigureOut">
              <a:rPr lang="en-US" smtClean="0"/>
              <a:t>3/2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1A1ED2B-10D3-4DC0-9239-71627F9C28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9BC629-B17F-481F-966C-9F07652AF9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BD483-5C1F-4296-AA4E-7CEBF09A7B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75706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DEFB8E-C752-48BC-A500-3CBA2BE700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2B168AA-EF41-41BF-BADD-B4130568873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5660EA-0F23-4449-B740-5AA3A2F3E8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38FF8-C19A-4E7F-824C-58AC62B8B22C}" type="datetimeFigureOut">
              <a:rPr lang="en-US" smtClean="0"/>
              <a:t>3/2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F87AAE-F9F4-439F-B81E-3BB308C3A2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45E62A-A3A2-4545-8CA7-50FAEC7728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BD483-5C1F-4296-AA4E-7CEBF09A7B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89773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A64138E-532F-4A69-ACBB-702F0F3F92F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96F8C48-B028-4933-918F-3027488CD95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D60762A-9E00-448E-A5D9-5A65785843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38FF8-C19A-4E7F-824C-58AC62B8B22C}" type="datetimeFigureOut">
              <a:rPr lang="en-US" smtClean="0"/>
              <a:t>3/2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F07A08-DB79-4487-901A-B7E9C99493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68C6DE-7C74-4E8E-808E-56FABE4BA9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BD483-5C1F-4296-AA4E-7CEBF09A7B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77441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FAD7E7-40D5-477A-8BF4-342490B115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B355CA7-6E71-4C1B-A5F2-4366C0861F8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9B897EA-6F36-45D1-886B-BC77146E30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38FF8-C19A-4E7F-824C-58AC62B8B22C}" type="datetimeFigureOut">
              <a:rPr lang="en-US" smtClean="0"/>
              <a:t>3/2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F809230-B962-4ED3-B88B-452FD1835B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9EC5CB-EEC0-4D5F-999D-B88A381834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BD483-5C1F-4296-AA4E-7CEBF09A7B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51352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4984CB-03DA-4DE2-B6CA-ABC6FFCFF1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A783E6C-DC22-45F0-8DCF-63DBC856CD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D3A0C1E-9758-401F-97DF-C5FFE63332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38FF8-C19A-4E7F-824C-58AC62B8B22C}" type="datetimeFigureOut">
              <a:rPr lang="en-US" smtClean="0"/>
              <a:t>3/2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07FD48F-BF83-40C6-82EC-23B81A2CA0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35109B-EDE6-43AB-8924-A11946B93C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BD483-5C1F-4296-AA4E-7CEBF09A7B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66328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67C027-7100-445E-A031-38576515D8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0DF6F99-4697-4FEA-A19C-EF9B44AEEF8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DAF1FC1-20C2-4EDD-9913-408683FDAA2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B8F3DDF-044C-4D12-8D13-9146FA3F0A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38FF8-C19A-4E7F-824C-58AC62B8B22C}" type="datetimeFigureOut">
              <a:rPr lang="en-US" smtClean="0"/>
              <a:t>3/27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9BDF146-30AB-41B9-A5B7-CB3FDB9D20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0F5606B-366E-4957-ACB0-C94CEB1039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BD483-5C1F-4296-AA4E-7CEBF09A7B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23167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305928-1BA3-405E-B1EB-279BE7A327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E8CF9B5-2DE3-4722-8D15-B1895C29D6B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D0D1DC2-05D8-4843-B057-B1B4A19CC7D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716B15C-75AF-4C97-9FAE-3A7D6D21E74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1E4A1B3-B643-4CAB-888A-837960BA696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0F7360F-15B3-4C02-B014-61E77B94F0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38FF8-C19A-4E7F-824C-58AC62B8B22C}" type="datetimeFigureOut">
              <a:rPr lang="en-US" smtClean="0"/>
              <a:t>3/27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2C46A82-6F99-4341-A086-F8FBEED4B8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B3E6E00-5DFD-4F41-957B-D2574EB04F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BD483-5C1F-4296-AA4E-7CEBF09A7B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25295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D4852B-5540-4B5C-BBC5-D0A6A29DDF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DE9C8CD-BB46-4626-82AC-CE9A0DC227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38FF8-C19A-4E7F-824C-58AC62B8B22C}" type="datetimeFigureOut">
              <a:rPr lang="en-US" smtClean="0"/>
              <a:t>3/27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7FDD369-9D53-47F0-A80C-2EE09759AC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FA647EE-EF4E-41A7-9A4D-ABEAEE06E1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BD483-5C1F-4296-AA4E-7CEBF09A7B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99736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22821433-5E88-47CA-99E3-BB10D933C1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38FF8-C19A-4E7F-824C-58AC62B8B22C}" type="datetimeFigureOut">
              <a:rPr lang="en-US" smtClean="0"/>
              <a:t>3/27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D210518-39EB-4905-8D18-C354335A75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6EB8C78-DD76-4939-AE64-4C8257261E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BD483-5C1F-4296-AA4E-7CEBF09A7B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97251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236AAC-31DB-4EAA-BD87-03192D6859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B3F70E-53CB-4BBC-B96F-DAA9110A19B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3D2F0B4-3279-48D8-B865-AFD220D8858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AD41087-F70E-4ECF-9F25-F539ABCDEE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38FF8-C19A-4E7F-824C-58AC62B8B22C}" type="datetimeFigureOut">
              <a:rPr lang="en-US" smtClean="0"/>
              <a:t>3/27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C2866CF-643A-4AB3-93EF-7BF508A678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C15507B-B2CB-4C38-B313-6BEDEFCAD7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BD483-5C1F-4296-AA4E-7CEBF09A7B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17935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CD94CF-4D44-4F90-909D-72E55AA680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35B074C-E47E-4876-9A5C-E38D33DE010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F118B53-C0DE-47EB-A74D-868ECAD394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4107417-EBE1-4278-8A91-249092EBCA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038FF8-C19A-4E7F-824C-58AC62B8B22C}" type="datetimeFigureOut">
              <a:rPr lang="en-US" smtClean="0"/>
              <a:t>3/27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82D990A-323F-4198-9D2B-174E87EAC3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B14B5D1-8F8C-46C3-8578-4E28B10B7C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1BD483-5C1F-4296-AA4E-7CEBF09A7B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80882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92F0F29-4BE7-478C-969B-711557AD0C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B6BD0C7-00BE-487A-8424-3551E439FA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9DB68C9-3948-4BAB-9B08-6B0DA2936B9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038FF8-C19A-4E7F-824C-58AC62B8B22C}" type="datetimeFigureOut">
              <a:rPr lang="en-US" smtClean="0"/>
              <a:t>3/2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2CD7DB-3009-42C1-BC4F-FD327C9B689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855A79-88D2-4953-BFDD-04D34A6249B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1BD483-5C1F-4296-AA4E-7CEBF09A7B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96605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7A634CC0-05AD-40C0-96A7-A7B5FEBA441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7000" y="0"/>
            <a:ext cx="6339155" cy="633915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1BB23F4B-BF68-8C82-BB92-521D4CDB8777}"/>
              </a:ext>
            </a:extLst>
          </p:cNvPr>
          <p:cNvSpPr txBox="1"/>
          <p:nvPr/>
        </p:nvSpPr>
        <p:spPr>
          <a:xfrm>
            <a:off x="2601074" y="6211669"/>
            <a:ext cx="7879422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Figure S3: Confusion matrix of Mask R-CNN results obtained from original RGB images obtained from wheat kernels’ HSI.</a:t>
            </a:r>
          </a:p>
        </p:txBody>
      </p:sp>
    </p:spTree>
    <p:extLst>
      <p:ext uri="{BB962C8B-B14F-4D97-AF65-F5344CB8AC3E}">
        <p14:creationId xmlns:p14="http://schemas.microsoft.com/office/powerpoint/2010/main" val="23558286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1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hakal, Kshitiz</dc:creator>
  <cp:lastModifiedBy>song li</cp:lastModifiedBy>
  <cp:revision>2</cp:revision>
  <dcterms:created xsi:type="dcterms:W3CDTF">2022-12-27T21:21:17Z</dcterms:created>
  <dcterms:modified xsi:type="dcterms:W3CDTF">2023-03-28T00:18:05Z</dcterms:modified>
</cp:coreProperties>
</file>